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086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82173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3830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46258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94452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3983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21016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84808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98251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97482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5123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2054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6369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914399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 smtClean="0">
                <a:latin typeface="Palatino Linotype" panose="02040502050505030304" pitchFamily="18" charset="0"/>
              </a:rPr>
              <a:t>Table</a:t>
            </a:r>
            <a:r>
              <a:rPr lang="ja-JP" altLang="en-US" sz="2000" b="1" dirty="0" smtClean="0">
                <a:latin typeface="Palatino Linotype" panose="02040502050505030304" pitchFamily="18" charset="0"/>
              </a:rPr>
              <a:t> </a:t>
            </a:r>
            <a:r>
              <a:rPr lang="en-US" altLang="ja-JP" sz="2000" b="1" dirty="0" smtClean="0">
                <a:latin typeface="Palatino Linotype" panose="02040502050505030304" pitchFamily="18" charset="0"/>
              </a:rPr>
              <a:t>S</a:t>
            </a:r>
            <a:r>
              <a:rPr lang="en-US" altLang="ja-JP" sz="2000" b="1" dirty="0" smtClean="0">
                <a:latin typeface="Palatino Linotype" panose="02040502050505030304" pitchFamily="18" charset="0"/>
              </a:rPr>
              <a:t>2</a:t>
            </a:r>
            <a:r>
              <a:rPr lang="en-US" altLang="ja-JP" sz="2000" b="1" dirty="0" smtClean="0">
                <a:latin typeface="Palatino Linotype" panose="02040502050505030304" pitchFamily="18" charset="0"/>
              </a:rPr>
              <a:t>.</a:t>
            </a:r>
            <a:r>
              <a:rPr lang="ja-JP" altLang="en-US" sz="2000" b="1" dirty="0" smtClean="0">
                <a:latin typeface="Palatino Linotype" panose="02040502050505030304" pitchFamily="18" charset="0"/>
              </a:rPr>
              <a:t> </a:t>
            </a:r>
            <a:r>
              <a:rPr lang="en-US" altLang="ja-JP" sz="2000" b="1" dirty="0" smtClean="0">
                <a:latin typeface="Palatino Linotype" panose="02040502050505030304" pitchFamily="18" charset="0"/>
              </a:rPr>
              <a:t>Measured urine</a:t>
            </a:r>
            <a:r>
              <a:rPr lang="ja-JP" altLang="en-US" sz="2000" b="1" dirty="0" smtClean="0">
                <a:latin typeface="Palatino Linotype" panose="02040502050505030304" pitchFamily="18" charset="0"/>
              </a:rPr>
              <a:t> </a:t>
            </a:r>
            <a:r>
              <a:rPr lang="en-US" altLang="ja-JP" sz="2000" b="1" dirty="0">
                <a:latin typeface="Palatino Linotype" panose="02040502050505030304" pitchFamily="18" charset="0"/>
              </a:rPr>
              <a:t>sodium and </a:t>
            </a:r>
            <a:r>
              <a:rPr lang="en-US" altLang="ja-JP" sz="2000" b="1" dirty="0" err="1" smtClean="0">
                <a:latin typeface="Palatino Linotype" panose="02040502050505030304" pitchFamily="18" charset="0"/>
              </a:rPr>
              <a:t>creatinine</a:t>
            </a:r>
            <a:r>
              <a:rPr lang="en-US" altLang="ja-JP" sz="2000" b="1" dirty="0" smtClean="0">
                <a:latin typeface="Palatino Linotype" panose="02040502050505030304" pitchFamily="18" charset="0"/>
              </a:rPr>
              <a:t>, estimated salt intake of participants.</a:t>
            </a:r>
            <a:endParaRPr kumimoji="1" lang="ja-JP" altLang="en-US" sz="2000" b="1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98721736"/>
              </p:ext>
            </p:extLst>
          </p:nvPr>
        </p:nvGraphicFramePr>
        <p:xfrm>
          <a:off x="6" y="1340768"/>
          <a:ext cx="9143992" cy="4473906"/>
        </p:xfrm>
        <a:graphic>
          <a:graphicData uri="http://schemas.openxmlformats.org/drawingml/2006/table">
            <a:tbl>
              <a:tblPr/>
              <a:tblGrid>
                <a:gridCol w="1363080"/>
                <a:gridCol w="766732"/>
                <a:gridCol w="766732"/>
                <a:gridCol w="766732"/>
                <a:gridCol w="1178496"/>
                <a:gridCol w="766732"/>
                <a:gridCol w="56796"/>
                <a:gridCol w="766732"/>
                <a:gridCol w="766732"/>
                <a:gridCol w="1178496"/>
                <a:gridCol w="766732"/>
              </a:tblGrid>
              <a:tr h="225434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 wk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 wk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450869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ea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SD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altLang="ja-JP" sz="1200" kern="1200" dirty="0" smtClean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Δ</a:t>
                      </a: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/>
                      </a:r>
                      <a:b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</a:b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9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ea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SD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altLang="ja-JP" sz="1200" kern="1200" dirty="0" smtClean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Δ</a:t>
                      </a: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/>
                      </a:r>
                      <a:b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</a:b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9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4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odium (mEq/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4.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55.6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3.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7.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</a:t>
                      </a:r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6.2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.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5434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28.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54.7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9.6 to 37.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243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24.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57.7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17.6 to 31.0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586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54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r (mg/d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0.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68.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.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6.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66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5434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0.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67.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19.0 to 38.9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495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5.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49.9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25.9 to 24.0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4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416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alt intake (g/day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3.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4.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3.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5.2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5434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2.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4.6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2.2 to 1.7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797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3.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3.9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2.5 to 1.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554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434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434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8 wk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2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wk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450869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ea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SD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altLang="ja-JP" sz="1200" kern="1200" dirty="0" smtClean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Δ</a:t>
                      </a: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/>
                      </a:r>
                      <a:b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</a:b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9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ea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SD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altLang="ja-JP" sz="1200" kern="1200" dirty="0" smtClean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Δ</a:t>
                      </a:r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/>
                      </a:r>
                      <a:b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</a:b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9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54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odium (mEq/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6.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53.7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.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23.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51.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.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5434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26.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56.9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12.8 to 34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367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32.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48.0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11.8 to 30.9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376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54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r (mg/dL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4.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77.5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9.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2.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65.1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5.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5434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4.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70.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41.1 to 22.0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550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6.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58.7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32.5 to 21.0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668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4735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alt intake (g/day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Placebo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2.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4.5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3.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5.6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5434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s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3.6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4.8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0.5 to 3.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153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4.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5.7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(-1.5 to 3.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439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" name="テキスト ボックス 1"/>
          <p:cNvSpPr txBox="1"/>
          <p:nvPr/>
        </p:nvSpPr>
        <p:spPr>
          <a:xfrm>
            <a:off x="1" y="6165304"/>
            <a:ext cx="914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</a:rPr>
              <a:t>Values are expressed as the </a:t>
            </a:r>
            <a:r>
              <a:rPr lang="en-US" altLang="ja-JP" sz="1200" dirty="0" smtClean="0">
                <a:latin typeface="Palatino Linotype" panose="02040502050505030304" pitchFamily="18" charset="0"/>
              </a:rPr>
              <a:t>mean</a:t>
            </a:r>
            <a:r>
              <a:rPr lang="ja-JP" altLang="en-US" sz="1200" dirty="0" smtClean="0">
                <a:latin typeface="Palatino Linotype" panose="02040502050505030304" pitchFamily="18" charset="0"/>
              </a:rPr>
              <a:t> </a:t>
            </a:r>
            <a:r>
              <a:rPr lang="en-US" altLang="ja-JP" sz="1200" dirty="0" smtClean="0">
                <a:latin typeface="Palatino Linotype" panose="02040502050505030304" pitchFamily="18" charset="0"/>
              </a:rPr>
              <a:t>(SD).</a:t>
            </a:r>
            <a:r>
              <a:rPr lang="ja-JP" altLang="en-US" sz="1200" dirty="0" smtClean="0">
                <a:latin typeface="Palatino Linotype" panose="02040502050505030304" pitchFamily="18" charset="0"/>
              </a:rPr>
              <a:t> </a:t>
            </a:r>
            <a:r>
              <a:rPr lang="en-US" altLang="ja-JP" sz="1200" dirty="0" smtClean="0">
                <a:latin typeface="Palatino Linotype" panose="02040502050505030304" pitchFamily="18" charset="0"/>
              </a:rPr>
              <a:t>Δ </a:t>
            </a:r>
            <a:r>
              <a:rPr lang="en-US" altLang="ja-JP" sz="1200" dirty="0">
                <a:latin typeface="Palatino Linotype" panose="02040502050505030304" pitchFamily="18" charset="0"/>
              </a:rPr>
              <a:t>indicates the difference in the averages of the test group and the placebo group (95% confidence interval).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26455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</TotalTime>
  <Words>300</Words>
  <Application>Microsoft Office PowerPoint</Application>
  <PresentationFormat>画面に合わせる (4:3)</PresentationFormat>
  <Paragraphs>13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SUNSTA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正箱 尚久</dc:creator>
  <cp:lastModifiedBy>正箱 尚久</cp:lastModifiedBy>
  <cp:revision>17</cp:revision>
  <dcterms:created xsi:type="dcterms:W3CDTF">2019-01-25T12:36:32Z</dcterms:created>
  <dcterms:modified xsi:type="dcterms:W3CDTF">2019-03-28T05:02:46Z</dcterms:modified>
</cp:coreProperties>
</file>